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91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1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E4D2"/>
    <a:srgbClr val="B8D8BE"/>
    <a:srgbClr val="5AA668"/>
    <a:srgbClr val="6FB17C"/>
    <a:srgbClr val="8DC197"/>
    <a:srgbClr val="0AA63A"/>
    <a:srgbClr val="663C30"/>
    <a:srgbClr val="E9D5CF"/>
    <a:srgbClr val="E3CAC3"/>
    <a:srgbClr val="D9A6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2395" autoAdjust="0"/>
  </p:normalViewPr>
  <p:slideViewPr>
    <p:cSldViewPr snapToGrid="0" showGuides="1">
      <p:cViewPr>
        <p:scale>
          <a:sx n="100" d="100"/>
          <a:sy n="100" d="100"/>
        </p:scale>
        <p:origin x="1284" y="-1752"/>
      </p:cViewPr>
      <p:guideLst>
        <p:guide orient="horz" pos="1351"/>
        <p:guide pos="206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35734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45550" y="3619501"/>
            <a:ext cx="57541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 | Diffusion of soil chemicals from rhizosphere to soil open areas.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Sr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es predicting elevation levels of soil in open areas. Models equation were developed on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imbricata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8 or 54 features)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.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igid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directly applied to the independent samples.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Sr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els were performed 50 times. Tukey’s tests were performed to compare predictions between elevation levels (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). In boxplots, the diamond represents the mean while the solid dark line represents the median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840F5E4-4C4D-FFCD-AD22-963C85AD8FCD}"/>
              </a:ext>
            </a:extLst>
          </p:cNvPr>
          <p:cNvSpPr/>
          <p:nvPr/>
        </p:nvSpPr>
        <p:spPr>
          <a:xfrm>
            <a:off x="545550" y="532868"/>
            <a:ext cx="5760000" cy="3086633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4" name="Image 3" descr="Une image contenant texte, capture d’écran, diagramme, Tracé&#10;&#10;Description générée automatiquement">
            <a:extLst>
              <a:ext uri="{FF2B5EF4-FFF2-40B4-BE49-F238E27FC236}">
                <a16:creationId xmlns:a16="http://schemas.microsoft.com/office/drawing/2014/main" id="{992D24ED-E5C8-47B4-AA41-CFF557780A5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588" y="573903"/>
            <a:ext cx="4680000" cy="3031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8349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06</TotalTime>
  <Words>92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Times New Roman</vt:lpstr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690</cp:revision>
  <dcterms:created xsi:type="dcterms:W3CDTF">2020-07-29T08:33:47Z</dcterms:created>
  <dcterms:modified xsi:type="dcterms:W3CDTF">2023-10-13T14:00:01Z</dcterms:modified>
</cp:coreProperties>
</file>